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8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ser" initials="U" lastIdx="6" clrIdx="0"/>
  <p:cmAuthor id="2" name="Susan" initials="SH" lastIdx="7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125E5076-3810-47DD-B79F-674D7AD40C01}" styleName="深色样式 1 - 强调 1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wholeTbl>
    <a:band1H>
      <a:tcStyle>
        <a:tcBdr/>
        <a:fill>
          <a:solidFill>
            <a:schemeClr val="accent1">
              <a:shade val="60000"/>
            </a:schemeClr>
          </a:solidFill>
        </a:fill>
      </a:tcStyle>
    </a:band1H>
    <a:band1V>
      <a:tcStyle>
        <a:tcBdr/>
        <a:fill>
          <a:solidFill>
            <a:schemeClr val="accent1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1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1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1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23" autoAdjust="0"/>
    <p:restoredTop sz="99451" autoAdjust="0"/>
  </p:normalViewPr>
  <p:slideViewPr>
    <p:cSldViewPr snapToGrid="0">
      <p:cViewPr varScale="1">
        <p:scale>
          <a:sx n="47" d="100"/>
          <a:sy n="47" d="100"/>
        </p:scale>
        <p:origin x="2400" y="6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esktop\1-Luciferase%20assay%20methodology%20paper\Figure%20S2%20GFP%20analysis%20raw%20dat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esktop\1-Luciferase%20assay%20methodology%20paper\Figure%20S2%20GFP%20analysis%20raw%20data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ser\Desktop\1-Luciferase%20assay%20methodology%20paper\Figure%20S2%20GFP%20analysis%20raw%20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4422826178985699"/>
          <c:y val="4.6107210915289798E-2"/>
          <c:w val="0.67644365422064501"/>
          <c:h val="0.80112658777555801"/>
        </c:manualLayout>
      </c:layout>
      <c:lineChart>
        <c:grouping val="standard"/>
        <c:varyColors val="0"/>
        <c:ser>
          <c:idx val="0"/>
          <c:order val="0"/>
          <c:tx>
            <c:strRef>
              <c:f>Day 2</c:f>
              <c:strCache>
                <c:ptCount val="1"/>
                <c:pt idx="0">
                  <c:v>Day 2</c:v>
                </c:pt>
              </c:strCache>
            </c:strRef>
          </c:tx>
          <c:spPr>
            <a:ln w="15875" cap="rnd" cmpd="sng" algn="ctr">
              <a:solidFill>
                <a:schemeClr val="tx1"/>
              </a:solidFill>
              <a:prstDash val="solid"/>
              <a:round/>
            </a:ln>
            <a:effectLst/>
          </c:spPr>
          <c:marker>
            <c:symbol val="circle"/>
            <c:size val="7"/>
            <c:spPr>
              <a:solidFill>
                <a:schemeClr val="bg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[1]Block summary'!$E$20,'[1]Block summary'!$E$15,'[1]Block summary'!$E$10,'[1]Block summary'!$E$5)</c:f>
                <c:numCache>
                  <c:formatCode>General</c:formatCode>
                  <c:ptCount val="4"/>
                  <c:pt idx="0">
                    <c:v>11551613.780397801</c:v>
                  </c:pt>
                  <c:pt idx="1">
                    <c:v>17633909.061036199</c:v>
                  </c:pt>
                  <c:pt idx="2">
                    <c:v>42132540.709844097</c:v>
                  </c:pt>
                  <c:pt idx="3">
                    <c:v>83897045.160522193</c:v>
                  </c:pt>
                </c:numCache>
              </c:numRef>
            </c:plus>
            <c:minus>
              <c:numRef>
                <c:f>('[1]Block summary'!$E$20,'[1]Block summary'!$E$15,'[1]Block summary'!$E$10,'[1]Block summary'!$E$5)</c:f>
                <c:numCache>
                  <c:formatCode>General</c:formatCode>
                  <c:ptCount val="4"/>
                  <c:pt idx="0">
                    <c:v>11551613.780397801</c:v>
                  </c:pt>
                  <c:pt idx="1">
                    <c:v>17633909.061036199</c:v>
                  </c:pt>
                  <c:pt idx="2">
                    <c:v>42132540.709844097</c:v>
                  </c:pt>
                  <c:pt idx="3">
                    <c:v>83897045.16052219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('C) 3D spheroids'!$F$25,'C) 3D spheroids'!$F$20,'C) 3D spheroids'!$F$15,'C) 3D spheroids'!$F$10,'C) 3D spheroids'!$F$5)</c:f>
              <c:numCache>
                <c:formatCode>General</c:formatCode>
                <c:ptCount val="5"/>
                <c:pt idx="0">
                  <c:v>0</c:v>
                </c:pt>
                <c:pt idx="1">
                  <c:v>2500</c:v>
                </c:pt>
                <c:pt idx="2">
                  <c:v>5000</c:v>
                </c:pt>
                <c:pt idx="3">
                  <c:v>10000</c:v>
                </c:pt>
                <c:pt idx="4">
                  <c:v>20000</c:v>
                </c:pt>
              </c:numCache>
            </c:numRef>
          </c:cat>
          <c:val>
            <c:numRef>
              <c:f>('C) 3D spheroids'!$D$25,'C) 3D spheroids'!$D$20,'C) 3D spheroids'!$D$15,'C) 3D spheroids'!$D$10,'C) 3D spheroids'!$D$5)</c:f>
              <c:numCache>
                <c:formatCode>0.00E+00</c:formatCode>
                <c:ptCount val="5"/>
                <c:pt idx="0" formatCode="General">
                  <c:v>1231523</c:v>
                </c:pt>
                <c:pt idx="1">
                  <c:v>46905026</c:v>
                </c:pt>
                <c:pt idx="2">
                  <c:v>98953618</c:v>
                </c:pt>
                <c:pt idx="3">
                  <c:v>243663333.33333299</c:v>
                </c:pt>
                <c:pt idx="4">
                  <c:v>562176666.666666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BA5-4219-887C-5F8FC264C7CF}"/>
            </c:ext>
          </c:extLst>
        </c:ser>
        <c:ser>
          <c:idx val="1"/>
          <c:order val="1"/>
          <c:tx>
            <c:strRef>
              <c:f>Day 4</c:f>
              <c:strCache>
                <c:ptCount val="1"/>
                <c:pt idx="0">
                  <c:v>Day 4</c:v>
                </c:pt>
              </c:strCache>
            </c:strRef>
          </c:tx>
          <c:spPr>
            <a:ln w="15875" cap="rnd" cmpd="sng" algn="ctr">
              <a:solidFill>
                <a:schemeClr val="tx1"/>
              </a:solidFill>
              <a:prstDash val="dash"/>
              <a:round/>
            </a:ln>
          </c:spPr>
          <c:marker>
            <c:symbol val="circle"/>
            <c:size val="7"/>
            <c:spPr>
              <a:solidFill>
                <a:schemeClr val="tx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C) 3D spheroids'!$I$25,'C) 3D spheroids'!$I$20,'C) 3D spheroids'!$I$15,'C) 3D spheroids'!$I$10,'C) 3D spheroids'!$I$5)</c:f>
                <c:numCache>
                  <c:formatCode>General</c:formatCode>
                  <c:ptCount val="5"/>
                  <c:pt idx="0">
                    <c:v>636071.55469585303</c:v>
                  </c:pt>
                  <c:pt idx="1">
                    <c:v>4850868.8904154003</c:v>
                  </c:pt>
                  <c:pt idx="2">
                    <c:v>15044378.795195701</c:v>
                  </c:pt>
                  <c:pt idx="3">
                    <c:v>26457513.110645901</c:v>
                  </c:pt>
                  <c:pt idx="4">
                    <c:v>65411919.5405173</c:v>
                  </c:pt>
                </c:numCache>
              </c:numRef>
            </c:plus>
            <c:minus>
              <c:numRef>
                <c:f>('C) 3D spheroids'!$I$5,'C) 3D spheroids'!$I$10,'C) 3D spheroids'!$I$15,'C) 3D spheroids'!$I$20,'C) 3D spheroids'!$I$25)</c:f>
                <c:numCache>
                  <c:formatCode>General</c:formatCode>
                  <c:ptCount val="5"/>
                  <c:pt idx="0">
                    <c:v>65411919.5405173</c:v>
                  </c:pt>
                  <c:pt idx="1">
                    <c:v>26457513.110645901</c:v>
                  </c:pt>
                  <c:pt idx="2">
                    <c:v>15044378.795195701</c:v>
                  </c:pt>
                  <c:pt idx="3">
                    <c:v>4850868.8904154003</c:v>
                  </c:pt>
                  <c:pt idx="4">
                    <c:v>636071.55469585303</c:v>
                  </c:pt>
                </c:numCache>
              </c:numRef>
            </c:minus>
          </c:errBars>
          <c:val>
            <c:numRef>
              <c:f>('C) 3D spheroids'!$H$25,'C) 3D spheroids'!$H$20,'C) 3D spheroids'!$H$15,'C) 3D spheroids'!$H$10,'C) 3D spheroids'!$H$5)</c:f>
              <c:numCache>
                <c:formatCode>0.00E+00</c:formatCode>
                <c:ptCount val="5"/>
                <c:pt idx="0" formatCode="General">
                  <c:v>4119833.2</c:v>
                </c:pt>
                <c:pt idx="1">
                  <c:v>45492382</c:v>
                </c:pt>
                <c:pt idx="2">
                  <c:v>104153618</c:v>
                </c:pt>
                <c:pt idx="3">
                  <c:v>240263333</c:v>
                </c:pt>
                <c:pt idx="4">
                  <c:v>616435333.200000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BA5-4219-887C-5F8FC264C7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968440"/>
        <c:axId val="144338896"/>
      </c:lineChart>
      <c:dateAx>
        <c:axId val="3968440"/>
        <c:scaling>
          <c:orientation val="minMax"/>
          <c:max val="20731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4338896"/>
        <c:crosses val="autoZero"/>
        <c:auto val="0"/>
        <c:lblOffset val="100"/>
        <c:baseTimeUnit val="days"/>
        <c:majorUnit val="5000"/>
        <c:majorTimeUnit val="days"/>
      </c:dateAx>
      <c:valAx>
        <c:axId val="144338896"/>
        <c:scaling>
          <c:orientation val="minMax"/>
          <c:min val="0"/>
        </c:scaling>
        <c:delete val="0"/>
        <c:axPos val="l"/>
        <c:numFmt formatCode="0.00E+0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968440"/>
        <c:crosses val="autoZero"/>
        <c:crossBetween val="midCat"/>
        <c:majorUnit val="150000000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25006587079840797"/>
          <c:y val="2.2544316852517201E-2"/>
          <c:w val="0.36780695961392101"/>
          <c:h val="0.23066245771691299"/>
        </c:manualLayout>
      </c:layout>
      <c:overlay val="0"/>
      <c:txPr>
        <a:bodyPr rot="0" spcFirstLastPara="0" vertOverflow="ellipsis" vert="horz" wrap="square" anchor="ctr" anchorCtr="1"/>
        <a:lstStyle/>
        <a:p>
          <a:pPr>
            <a:defRPr lang="en-US"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en-US" sz="900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786966774278799"/>
          <c:y val="8.2824146981628002E-2"/>
          <c:w val="0.69821908640755503"/>
          <c:h val="0.69197397557156404"/>
        </c:manualLayout>
      </c:layout>
      <c:lineChart>
        <c:grouping val="standard"/>
        <c:varyColors val="0"/>
        <c:ser>
          <c:idx val="0"/>
          <c:order val="0"/>
          <c:tx>
            <c:strRef>
              <c:f>Day 2</c:f>
              <c:strCache>
                <c:ptCount val="1"/>
                <c:pt idx="0">
                  <c:v>Day 2</c:v>
                </c:pt>
              </c:strCache>
            </c:strRef>
          </c:tx>
          <c:spPr>
            <a:ln w="15875" cap="rnd" cmpd="sng" algn="ctr">
              <a:solidFill>
                <a:schemeClr val="tx1"/>
              </a:solidFill>
              <a:prstDash val="solid"/>
              <a:round/>
            </a:ln>
          </c:spPr>
          <c:marker>
            <c:symbol val="triangle"/>
            <c:size val="7"/>
            <c:spPr>
              <a:solidFill>
                <a:schemeClr val="bg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A) Non-depleted'!$E$26,'A) Non-depleted'!$E$23,'A) Non-depleted'!$E$17,'A) Non-depleted'!$E$11,'A) Non-depleted'!$E$5)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512988.4224870498</c:v>
                  </c:pt>
                  <c:pt idx="2">
                    <c:v>3680499.9891829798</c:v>
                  </c:pt>
                  <c:pt idx="3">
                    <c:v>14059898.5378902</c:v>
                  </c:pt>
                  <c:pt idx="4">
                    <c:v>8958024.9625863507</c:v>
                  </c:pt>
                </c:numCache>
              </c:numRef>
            </c:plus>
            <c:minus>
              <c:numRef>
                <c:f>('A) Non-depleted'!$E$26,'A) Non-depleted'!$E$23,'A) Non-depleted'!$E$17,'A) Non-depleted'!$E$11,'A) Non-depleted'!$E$5)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512988.4224870498</c:v>
                  </c:pt>
                  <c:pt idx="2">
                    <c:v>3680499.9891829798</c:v>
                  </c:pt>
                  <c:pt idx="3">
                    <c:v>14059898.5378902</c:v>
                  </c:pt>
                  <c:pt idx="4">
                    <c:v>8958024.96258635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('A) Non-depleted'!$F$26,'A) Non-depleted'!$F$23,'A) Non-depleted'!$F$17,'A) Non-depleted'!$F$11,'A) Non-depleted'!$F$5)</c:f>
              <c:numCache>
                <c:formatCode>General</c:formatCode>
                <c:ptCount val="5"/>
                <c:pt idx="0">
                  <c:v>0</c:v>
                </c:pt>
                <c:pt idx="1">
                  <c:v>2500</c:v>
                </c:pt>
                <c:pt idx="2">
                  <c:v>5000</c:v>
                </c:pt>
                <c:pt idx="3">
                  <c:v>10000</c:v>
                </c:pt>
                <c:pt idx="4">
                  <c:v>20000</c:v>
                </c:pt>
              </c:numCache>
            </c:numRef>
          </c:cat>
          <c:val>
            <c:numRef>
              <c:f>('A) Non-depleted'!$D$26,'A) Non-depleted'!$D$23,'A) Non-depleted'!$D$17,'A) Non-depleted'!$D$11,'A) Non-depleted'!$D$5)</c:f>
              <c:numCache>
                <c:formatCode>0.00E+00</c:formatCode>
                <c:ptCount val="5"/>
                <c:pt idx="0" formatCode="General">
                  <c:v>100000</c:v>
                </c:pt>
                <c:pt idx="1">
                  <c:v>11912785</c:v>
                </c:pt>
                <c:pt idx="2">
                  <c:v>23962066.333333399</c:v>
                </c:pt>
                <c:pt idx="3">
                  <c:v>52663404.666666701</c:v>
                </c:pt>
                <c:pt idx="4">
                  <c:v>111655026.8333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542-4D46-9CB4-F8D500256A62}"/>
            </c:ext>
          </c:extLst>
        </c:ser>
        <c:ser>
          <c:idx val="1"/>
          <c:order val="1"/>
          <c:tx>
            <c:strRef>
              <c:f>Day 4</c:f>
              <c:strCache>
                <c:ptCount val="1"/>
                <c:pt idx="0">
                  <c:v>Day 4</c:v>
                </c:pt>
              </c:strCache>
            </c:strRef>
          </c:tx>
          <c:spPr>
            <a:ln w="15875" cap="rnd" cmpd="sng" algn="ctr">
              <a:solidFill>
                <a:schemeClr val="tx1"/>
              </a:solidFill>
              <a:prstDash val="dash"/>
              <a:round/>
            </a:ln>
          </c:spPr>
          <c:marker>
            <c:symbol val="triangle"/>
            <c:size val="7"/>
            <c:spPr>
              <a:solidFill>
                <a:schemeClr val="tx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A) Non-depleted'!$I$5,'A) Non-depleted'!$I$11,'A) Non-depleted'!$I$17,'A) Non-depleted'!$I$23,'A) Non-depleted'!$I$26)</c:f>
                <c:numCache>
                  <c:formatCode>General</c:formatCode>
                  <c:ptCount val="5"/>
                  <c:pt idx="0">
                    <c:v>19833473.388861202</c:v>
                  </c:pt>
                  <c:pt idx="1">
                    <c:v>9217736.5262121893</c:v>
                  </c:pt>
                  <c:pt idx="2">
                    <c:v>3726347.6309472998</c:v>
                  </c:pt>
                  <c:pt idx="3">
                    <c:v>2608320.02126528</c:v>
                  </c:pt>
                  <c:pt idx="4">
                    <c:v>0</c:v>
                  </c:pt>
                </c:numCache>
              </c:numRef>
            </c:plus>
            <c:minus>
              <c:numRef>
                <c:f>('A) Non-depleted'!$I$5,'A) Non-depleted'!$I$11,'A) Non-depleted'!$I$17,'A) Non-depleted'!$I$23,'A) Non-depleted'!$I$26)</c:f>
                <c:numCache>
                  <c:formatCode>General</c:formatCode>
                  <c:ptCount val="5"/>
                  <c:pt idx="0">
                    <c:v>19833473.388861202</c:v>
                  </c:pt>
                  <c:pt idx="1">
                    <c:v>9217736.5262121893</c:v>
                  </c:pt>
                  <c:pt idx="2">
                    <c:v>3726347.6309472998</c:v>
                  </c:pt>
                  <c:pt idx="3">
                    <c:v>2608320.02126528</c:v>
                  </c:pt>
                  <c:pt idx="4">
                    <c:v>0</c:v>
                  </c:pt>
                </c:numCache>
              </c:numRef>
            </c:minus>
          </c:errBars>
          <c:val>
            <c:numRef>
              <c:f>('A) Non-depleted'!$H$26,'A) Non-depleted'!$H$23,'A) Non-depleted'!$H$17,'A) Non-depleted'!$H$11,'A) Non-depleted'!$H$5)</c:f>
              <c:numCache>
                <c:formatCode>0.00E+00</c:formatCode>
                <c:ptCount val="5"/>
                <c:pt idx="0" formatCode="General">
                  <c:v>235232</c:v>
                </c:pt>
                <c:pt idx="1">
                  <c:v>18766666.666666701</c:v>
                </c:pt>
                <c:pt idx="2">
                  <c:v>42083333.333333299</c:v>
                </c:pt>
                <c:pt idx="3">
                  <c:v>110833333.333333</c:v>
                </c:pt>
                <c:pt idx="4">
                  <c:v>223166666.666667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542-4D46-9CB4-F8D500256A6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3190408"/>
        <c:axId val="143830424"/>
      </c:lineChart>
      <c:dateAx>
        <c:axId val="143190408"/>
        <c:scaling>
          <c:orientation val="minMax"/>
          <c:max val="20731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3830424"/>
        <c:crosses val="autoZero"/>
        <c:auto val="0"/>
        <c:lblOffset val="100"/>
        <c:baseTimeUnit val="days"/>
        <c:majorUnit val="5000"/>
        <c:majorTimeUnit val="days"/>
      </c:dateAx>
      <c:valAx>
        <c:axId val="143830424"/>
        <c:scaling>
          <c:orientation val="minMax"/>
          <c:min val="0"/>
        </c:scaling>
        <c:delete val="0"/>
        <c:axPos val="l"/>
        <c:numFmt formatCode="0.00E+0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43190408"/>
        <c:crosses val="autoZero"/>
        <c:crossBetween val="midCat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20557055060353199"/>
          <c:y val="7.2964829396325495E-2"/>
          <c:w val="0.39634769821118798"/>
          <c:h val="0.200626113027947"/>
        </c:manualLayout>
      </c:layout>
      <c:overlay val="0"/>
      <c:txPr>
        <a:bodyPr rot="0" spcFirstLastPara="0" vertOverflow="ellipsis" vert="horz" wrap="square" anchor="ctr" anchorCtr="1"/>
        <a:lstStyle/>
        <a:p>
          <a:pPr>
            <a:defRPr lang="en-US"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en-US">
          <a:solidFill>
            <a:schemeClr val="tx1"/>
          </a:solidFill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1677947349814"/>
          <c:y val="7.7310634535916398E-2"/>
          <c:w val="0.69923835708979898"/>
          <c:h val="0.71711820286100403"/>
        </c:manualLayout>
      </c:layout>
      <c:lineChart>
        <c:grouping val="standard"/>
        <c:varyColors val="0"/>
        <c:ser>
          <c:idx val="1"/>
          <c:order val="0"/>
          <c:tx>
            <c:strRef>
              <c:f>Day 2</c:f>
              <c:strCache>
                <c:ptCount val="1"/>
                <c:pt idx="0">
                  <c:v>Day 2</c:v>
                </c:pt>
              </c:strCache>
            </c:strRef>
          </c:tx>
          <c:spPr>
            <a:ln w="15875" cap="rnd" cmpd="sng" algn="ctr">
              <a:solidFill>
                <a:schemeClr val="tx1"/>
              </a:solidFill>
              <a:prstDash val="solid"/>
              <a:round/>
            </a:ln>
          </c:spPr>
          <c:marker>
            <c:symbol val="square"/>
            <c:size val="7"/>
            <c:spPr>
              <a:solidFill>
                <a:schemeClr val="bg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B) Mouse-depleted'!$E$26,'B) Mouse-depleted'!$E$47,'B) Mouse-depleted'!$E$41,'B) Mouse-depleted'!$E$35,'B) Mouse-depleted'!$E$29)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895780.8734623198</c:v>
                  </c:pt>
                  <c:pt idx="2">
                    <c:v>14575498.303657399</c:v>
                  </c:pt>
                  <c:pt idx="3">
                    <c:v>3376748.60866667</c:v>
                  </c:pt>
                  <c:pt idx="4">
                    <c:v>35282766.803828299</c:v>
                  </c:pt>
                </c:numCache>
              </c:numRef>
            </c:plus>
            <c:minus>
              <c:numRef>
                <c:f>('B) Mouse-depleted'!$E$26,'B) Mouse-depleted'!$E$47,'B) Mouse-depleted'!$E$41,'B) Mouse-depleted'!$E$35,'B) Mouse-depleted'!$E$29)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895780.8734623198</c:v>
                  </c:pt>
                  <c:pt idx="2">
                    <c:v>14575498.303657399</c:v>
                  </c:pt>
                  <c:pt idx="3">
                    <c:v>3376748.60866667</c:v>
                  </c:pt>
                  <c:pt idx="4">
                    <c:v>35282766.8038282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prstDash val="solid"/>
                <a:round/>
              </a:ln>
              <a:effectLst/>
            </c:spPr>
          </c:errBars>
          <c:cat>
            <c:numRef>
              <c:f>('B) Mouse-depleted'!$F$26,'B) Mouse-depleted'!$F$23,'B) Mouse-depleted'!$F$17,'B) Mouse-depleted'!$F$11,'B) Mouse-depleted'!$F$5)</c:f>
              <c:numCache>
                <c:formatCode>General</c:formatCode>
                <c:ptCount val="5"/>
                <c:pt idx="0">
                  <c:v>0</c:v>
                </c:pt>
                <c:pt idx="1">
                  <c:v>2500</c:v>
                </c:pt>
                <c:pt idx="2">
                  <c:v>5000</c:v>
                </c:pt>
                <c:pt idx="3">
                  <c:v>10000</c:v>
                </c:pt>
                <c:pt idx="4">
                  <c:v>20000</c:v>
                </c:pt>
              </c:numCache>
            </c:numRef>
          </c:cat>
          <c:val>
            <c:numRef>
              <c:f>('B) Mouse-depleted'!$D$26,'B) Mouse-depleted'!$D$47,'B) Mouse-depleted'!$D$41,'B) Mouse-depleted'!$D$35,'B) Mouse-depleted'!$D$29)</c:f>
              <c:numCache>
                <c:formatCode>0.00E+00</c:formatCode>
                <c:ptCount val="5"/>
                <c:pt idx="0" formatCode="General">
                  <c:v>532612</c:v>
                </c:pt>
                <c:pt idx="1">
                  <c:v>16009148.3333333</c:v>
                </c:pt>
                <c:pt idx="2">
                  <c:v>35404513</c:v>
                </c:pt>
                <c:pt idx="3">
                  <c:v>86756196.666666701</c:v>
                </c:pt>
                <c:pt idx="4">
                  <c:v>140013333.333332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603-4607-9485-C396C69268DE}"/>
            </c:ext>
          </c:extLst>
        </c:ser>
        <c:ser>
          <c:idx val="0"/>
          <c:order val="1"/>
          <c:tx>
            <c:strRef>
              <c:f>Day 4</c:f>
              <c:strCache>
                <c:ptCount val="1"/>
                <c:pt idx="0">
                  <c:v>Day 4</c:v>
                </c:pt>
              </c:strCache>
            </c:strRef>
          </c:tx>
          <c:spPr>
            <a:ln w="15875" cap="rnd" cmpd="sng" algn="ctr">
              <a:solidFill>
                <a:schemeClr val="tx1"/>
              </a:solidFill>
              <a:prstDash val="dash"/>
              <a:round/>
            </a:ln>
          </c:spPr>
          <c:marker>
            <c:symbol val="square"/>
            <c:size val="7"/>
            <c:spPr>
              <a:solidFill>
                <a:schemeClr val="tx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('B) Mouse-depleted'!$I$5,'B) Mouse-depleted'!$I$11,'B) Mouse-depleted'!$I$17,'B) Mouse-depleted'!$I$23,'B) Mouse-depleted'!$I$26)</c:f>
                <c:numCache>
                  <c:formatCode>General</c:formatCode>
                  <c:ptCount val="5"/>
                  <c:pt idx="0">
                    <c:v>28083209.693100698</c:v>
                  </c:pt>
                  <c:pt idx="1">
                    <c:v>41734478.152561903</c:v>
                  </c:pt>
                  <c:pt idx="2">
                    <c:v>21311186.4209073</c:v>
                  </c:pt>
                  <c:pt idx="3">
                    <c:v>2818391.97652373</c:v>
                  </c:pt>
                  <c:pt idx="4">
                    <c:v>26765.972135032502</c:v>
                  </c:pt>
                </c:numCache>
              </c:numRef>
            </c:plus>
            <c:minus>
              <c:numRef>
                <c:f>('B) Mouse-depleted'!$I$5,'B) Mouse-depleted'!$I$11,'B) Mouse-depleted'!$I$17,'B) Mouse-depleted'!$I$23,'B) Mouse-depleted'!$I$26)</c:f>
                <c:numCache>
                  <c:formatCode>General</c:formatCode>
                  <c:ptCount val="5"/>
                  <c:pt idx="0">
                    <c:v>28083209.693100698</c:v>
                  </c:pt>
                  <c:pt idx="1">
                    <c:v>41734478.152561903</c:v>
                  </c:pt>
                  <c:pt idx="2">
                    <c:v>21311186.4209073</c:v>
                  </c:pt>
                  <c:pt idx="3">
                    <c:v>2818391.97652373</c:v>
                  </c:pt>
                  <c:pt idx="4">
                    <c:v>26765.972135032502</c:v>
                  </c:pt>
                </c:numCache>
              </c:numRef>
            </c:minus>
          </c:errBars>
          <c:cat>
            <c:numRef>
              <c:f>('B) Mouse-depleted'!$F$26,'B) Mouse-depleted'!$F$23,'B) Mouse-depleted'!$F$17,'B) Mouse-depleted'!$F$11,'B) Mouse-depleted'!$F$5)</c:f>
              <c:numCache>
                <c:formatCode>General</c:formatCode>
                <c:ptCount val="5"/>
                <c:pt idx="0">
                  <c:v>0</c:v>
                </c:pt>
                <c:pt idx="1">
                  <c:v>2500</c:v>
                </c:pt>
                <c:pt idx="2">
                  <c:v>5000</c:v>
                </c:pt>
                <c:pt idx="3">
                  <c:v>10000</c:v>
                </c:pt>
                <c:pt idx="4">
                  <c:v>20000</c:v>
                </c:pt>
              </c:numCache>
            </c:numRef>
          </c:cat>
          <c:val>
            <c:numRef>
              <c:f>('B) Mouse-depleted'!$H$26,'B) Mouse-depleted'!$H$23,'B) Mouse-depleted'!$H$17,'B) Mouse-depleted'!$H$11,'B) Mouse-depleted'!$H$5)</c:f>
              <c:numCache>
                <c:formatCode>0.00E+00</c:formatCode>
                <c:ptCount val="5"/>
                <c:pt idx="0" formatCode="General">
                  <c:v>496016.333333335</c:v>
                </c:pt>
                <c:pt idx="1">
                  <c:v>35733333.333333299</c:v>
                </c:pt>
                <c:pt idx="2">
                  <c:v>109833333.333333</c:v>
                </c:pt>
                <c:pt idx="3">
                  <c:v>203833333.33333299</c:v>
                </c:pt>
                <c:pt idx="4">
                  <c:v>406666666.666666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603-4607-9485-C396C69268D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5513960"/>
        <c:axId val="85511128"/>
      </c:lineChart>
      <c:dateAx>
        <c:axId val="85513960"/>
        <c:scaling>
          <c:orientation val="minMax"/>
          <c:max val="20731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5511128"/>
        <c:crosses val="autoZero"/>
        <c:auto val="0"/>
        <c:lblOffset val="100"/>
        <c:baseTimeUnit val="days"/>
        <c:majorUnit val="5000"/>
        <c:majorTimeUnit val="days"/>
      </c:dateAx>
      <c:valAx>
        <c:axId val="85511128"/>
        <c:scaling>
          <c:orientation val="minMax"/>
          <c:min val="0"/>
        </c:scaling>
        <c:delete val="0"/>
        <c:axPos val="l"/>
        <c:numFmt formatCode="0.00E+00" sourceLinked="0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en-US"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5513960"/>
        <c:crosses val="autoZero"/>
        <c:crossBetween val="midCat"/>
        <c:majorUnit val="100000000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243750420431468"/>
          <c:y val="6.0769735513830102E-2"/>
          <c:w val="0.32817806829095503"/>
          <c:h val="0.190470421966485"/>
        </c:manualLayout>
      </c:layout>
      <c:overlay val="0"/>
      <c:spPr>
        <a:noFill/>
        <a:ln w="25400">
          <a:noFill/>
        </a:ln>
      </c:spPr>
      <c:txPr>
        <a:bodyPr rot="0" spcFirstLastPara="0" vertOverflow="ellipsis" vert="horz" wrap="square" anchor="ctr" anchorCtr="1"/>
        <a:lstStyle/>
        <a:p>
          <a:pPr>
            <a:defRPr lang="en-US" sz="900" b="0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en-US" sz="9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MY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DCF59D-A455-4455-9255-F234A60AEA7F}" type="datetimeFigureOut">
              <a:rPr lang="en-MY" smtClean="0"/>
              <a:t>15/4/2019</a:t>
            </a:fld>
            <a:endParaRPr lang="en-MY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MY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MY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MY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86F327B-117E-4541-90F5-D88BEF3E3B97}" type="slidenum">
              <a:rPr lang="en-MY" smtClean="0"/>
              <a:t>‹#›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30386944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86F327B-117E-4541-90F5-D88BEF3E3B97}" type="slidenum">
              <a:rPr lang="en-MY" smtClean="0"/>
              <a:t>1</a:t>
            </a:fld>
            <a:endParaRPr lang="en-MY"/>
          </a:p>
        </p:txBody>
      </p:sp>
    </p:spTree>
    <p:extLst>
      <p:ext uri="{BB962C8B-B14F-4D97-AF65-F5344CB8AC3E}">
        <p14:creationId xmlns:p14="http://schemas.microsoft.com/office/powerpoint/2010/main" val="22225483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10F021-1274-47D2-AFB4-0EE6EC0B1E33}" type="datetime1">
              <a:rPr lang="en-US" smtClean="0"/>
              <a:t>4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A572A7-9A5D-4E98-845A-D0069E1C6B40}" type="datetime1">
              <a:rPr lang="en-US" smtClean="0"/>
              <a:t>4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EC581F-F929-44D6-A4CE-8F76130C8A54}" type="datetime1">
              <a:rPr lang="en-US" smtClean="0"/>
              <a:t>4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898D11-9C37-461D-B76B-EFCBB1704881}" type="datetime1">
              <a:rPr lang="en-US" smtClean="0"/>
              <a:t>4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D79D7-8623-4FAA-AC6D-0C7555325C6A}" type="datetime1">
              <a:rPr lang="en-US" smtClean="0"/>
              <a:t>4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1C212A-426F-4445-BFB7-8BD5D91CDD04}" type="datetime1">
              <a:rPr lang="en-US" smtClean="0"/>
              <a:t>4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A0040-B0A6-418F-8278-AEDD500E1F0D}" type="datetime1">
              <a:rPr lang="en-US" smtClean="0"/>
              <a:t>4/1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D6D794-079F-4B44-A7C3-68E3BA215814}" type="datetime1">
              <a:rPr lang="en-US" smtClean="0"/>
              <a:t>4/1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F6ABCD-F7FF-47DE-A90E-574F763FE900}" type="datetime1">
              <a:rPr lang="en-US" smtClean="0"/>
              <a:t>4/1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DB0F0F-09D8-408F-B710-8B995EEBC957}" type="datetime1">
              <a:rPr lang="en-US" smtClean="0"/>
              <a:t>4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E643E9-AB3F-4C16-8F61-3D81199BDB44}" type="datetime1">
              <a:rPr lang="en-US" smtClean="0"/>
              <a:t>4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BBCF2E-4AE9-41F0-A139-1AF658B2506B}" type="datetime1">
              <a:rPr lang="en-US" smtClean="0"/>
              <a:t>4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3" Type="http://schemas.openxmlformats.org/officeDocument/2006/relationships/chart" Target="../charts/chart1.xml"/><Relationship Id="rId7" Type="http://schemas.openxmlformats.org/officeDocument/2006/relationships/image" Target="../media/image4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jpeg"/><Relationship Id="rId5" Type="http://schemas.openxmlformats.org/officeDocument/2006/relationships/image" Target="../media/image2.jpeg"/><Relationship Id="rId4" Type="http://schemas.openxmlformats.org/officeDocument/2006/relationships/image" Target="../media/image1.jpeg"/><Relationship Id="rId9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Chart 40"/>
          <p:cNvGraphicFramePr/>
          <p:nvPr/>
        </p:nvGraphicFramePr>
        <p:xfrm>
          <a:off x="2019300" y="4246475"/>
          <a:ext cx="2952750" cy="17261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25" name="Straight Connector 24"/>
          <p:cNvCxnSpPr/>
          <p:nvPr/>
        </p:nvCxnSpPr>
        <p:spPr>
          <a:xfrm>
            <a:off x="1828800" y="386444"/>
            <a:ext cx="0" cy="53149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/>
          <p:cNvCxnSpPr/>
          <p:nvPr/>
        </p:nvCxnSpPr>
        <p:spPr>
          <a:xfrm>
            <a:off x="2647950" y="6875376"/>
            <a:ext cx="23241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3252086" y="6948599"/>
            <a:ext cx="11489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1400" dirty="0" smtClean="0"/>
              <a:t>Cell </a:t>
            </a:r>
            <a:r>
              <a:rPr lang="en-MY" sz="1400" dirty="0"/>
              <a:t>number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1397000" y="1619052"/>
            <a:ext cx="400110" cy="264814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400" b="1" dirty="0"/>
              <a:t>Relative fluorescence </a:t>
            </a:r>
            <a:r>
              <a:rPr lang="en-US" sz="1400" b="1" dirty="0" smtClean="0"/>
              <a:t>unit (RFU)</a:t>
            </a:r>
            <a:endParaRPr lang="en-MY" sz="1400" b="1" dirty="0"/>
          </a:p>
        </p:txBody>
      </p:sp>
      <p:cxnSp>
        <p:nvCxnSpPr>
          <p:cNvPr id="34" name="Straight Connector 33"/>
          <p:cNvCxnSpPr/>
          <p:nvPr/>
        </p:nvCxnSpPr>
        <p:spPr>
          <a:xfrm>
            <a:off x="4991100" y="2311400"/>
            <a:ext cx="0" cy="14668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4991100" y="368300"/>
            <a:ext cx="0" cy="140970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/>
          <p:cNvSpPr txBox="1"/>
          <p:nvPr/>
        </p:nvSpPr>
        <p:spPr>
          <a:xfrm>
            <a:off x="1880755" y="292100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A</a:t>
            </a:r>
            <a:endParaRPr lang="en-MY" sz="14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1880755" y="2219523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B</a:t>
            </a:r>
            <a:endParaRPr lang="en-MY" sz="14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1899805" y="4178333"/>
            <a:ext cx="457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C</a:t>
            </a:r>
            <a:endParaRPr lang="en-MY" sz="1400" b="1" dirty="0"/>
          </a:p>
        </p:txBody>
      </p:sp>
      <p:pic>
        <p:nvPicPr>
          <p:cNvPr id="47" name="Picture 4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00" t="28018" r="27000" b="25981"/>
          <a:stretch>
            <a:fillRect/>
          </a:stretch>
        </p:blipFill>
        <p:spPr>
          <a:xfrm>
            <a:off x="2762498" y="6150188"/>
            <a:ext cx="457200" cy="457200"/>
          </a:xfrm>
          <a:prstGeom prst="rect">
            <a:avLst/>
          </a:prstGeom>
        </p:spPr>
      </p:pic>
      <p:pic>
        <p:nvPicPr>
          <p:cNvPr id="48" name="Picture 4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303" t="29292" r="27511" b="25522"/>
          <a:stretch>
            <a:fillRect/>
          </a:stretch>
        </p:blipFill>
        <p:spPr>
          <a:xfrm>
            <a:off x="3273949" y="6150188"/>
            <a:ext cx="457200" cy="457200"/>
          </a:xfrm>
          <a:prstGeom prst="rect">
            <a:avLst/>
          </a:prstGeom>
        </p:spPr>
      </p:pic>
      <p:pic>
        <p:nvPicPr>
          <p:cNvPr id="49" name="Picture 4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768" t="35208" r="22845" b="19405"/>
          <a:stretch>
            <a:fillRect/>
          </a:stretch>
        </p:blipFill>
        <p:spPr>
          <a:xfrm>
            <a:off x="3810368" y="6148699"/>
            <a:ext cx="457199" cy="457199"/>
          </a:xfrm>
          <a:prstGeom prst="rect">
            <a:avLst/>
          </a:prstGeom>
        </p:spPr>
      </p:pic>
      <p:pic>
        <p:nvPicPr>
          <p:cNvPr id="50" name="Picture 4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04" t="28980" r="19210" b="25634"/>
          <a:stretch>
            <a:fillRect/>
          </a:stretch>
        </p:blipFill>
        <p:spPr>
          <a:xfrm>
            <a:off x="4346787" y="6150187"/>
            <a:ext cx="457201" cy="457201"/>
          </a:xfrm>
          <a:prstGeom prst="rect">
            <a:avLst/>
          </a:prstGeom>
        </p:spPr>
      </p:pic>
      <p:sp>
        <p:nvSpPr>
          <p:cNvPr id="51" name="TextBox 50"/>
          <p:cNvSpPr txBox="1"/>
          <p:nvPr/>
        </p:nvSpPr>
        <p:spPr>
          <a:xfrm>
            <a:off x="2682585" y="6602784"/>
            <a:ext cx="32766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MY" sz="1000" dirty="0"/>
              <a:t> 143 </a:t>
            </a:r>
            <a:r>
              <a:rPr lang="en-MY" sz="1000" dirty="0">
                <a:latin typeface="Calibri" panose="020F0502020204030204" pitchFamily="34" charset="0"/>
              </a:rPr>
              <a:t>µm</a:t>
            </a:r>
            <a:r>
              <a:rPr lang="en-MY" sz="1000" dirty="0"/>
              <a:t>    196 </a:t>
            </a:r>
            <a:r>
              <a:rPr lang="en-MY" sz="1000" dirty="0">
                <a:latin typeface="Calibri" panose="020F0502020204030204" pitchFamily="34" charset="0"/>
              </a:rPr>
              <a:t>µm</a:t>
            </a:r>
            <a:r>
              <a:rPr lang="en-MY" sz="1000" dirty="0"/>
              <a:t>     264 </a:t>
            </a:r>
            <a:r>
              <a:rPr lang="en-MY" sz="1000" dirty="0">
                <a:latin typeface="Calibri" panose="020F0502020204030204" pitchFamily="34" charset="0"/>
              </a:rPr>
              <a:t>µm</a:t>
            </a:r>
            <a:r>
              <a:rPr lang="en-MY" sz="1000" dirty="0"/>
              <a:t>     347 </a:t>
            </a:r>
            <a:r>
              <a:rPr lang="en-MY" sz="1000" dirty="0">
                <a:latin typeface="Calibri" panose="020F0502020204030204" pitchFamily="34" charset="0"/>
              </a:rPr>
              <a:t>µm</a:t>
            </a:r>
            <a:endParaRPr lang="en-MY" sz="1000" dirty="0"/>
          </a:p>
        </p:txBody>
      </p:sp>
      <p:cxnSp>
        <p:nvCxnSpPr>
          <p:cNvPr id="9" name="Straight Connector 8"/>
          <p:cNvCxnSpPr/>
          <p:nvPr/>
        </p:nvCxnSpPr>
        <p:spPr>
          <a:xfrm flipH="1">
            <a:off x="2904888" y="6563432"/>
            <a:ext cx="100011" cy="1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Connector 52"/>
          <p:cNvCxnSpPr/>
          <p:nvPr/>
        </p:nvCxnSpPr>
        <p:spPr>
          <a:xfrm flipH="1">
            <a:off x="3417711" y="6561052"/>
            <a:ext cx="135908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Connector 55"/>
          <p:cNvCxnSpPr/>
          <p:nvPr/>
        </p:nvCxnSpPr>
        <p:spPr>
          <a:xfrm flipH="1">
            <a:off x="3925284" y="6561052"/>
            <a:ext cx="16845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 flipH="1">
            <a:off x="4461763" y="6561052"/>
            <a:ext cx="220473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5084285" y="344062"/>
            <a:ext cx="400110" cy="6248400"/>
          </a:xfrm>
          <a:prstGeom prst="rect">
            <a:avLst/>
          </a:prstGeom>
          <a:noFill/>
        </p:spPr>
        <p:txBody>
          <a:bodyPr vert="vert" wrap="square" rtlCol="0">
            <a:spAutoFit/>
          </a:bodyPr>
          <a:lstStyle/>
          <a:p>
            <a:r>
              <a:rPr lang="en-MY" sz="1400" b="1" dirty="0"/>
              <a:t>Non-depleted (2D)       </a:t>
            </a:r>
            <a:r>
              <a:rPr lang="en-MY" sz="1400" b="1" dirty="0" smtClean="0"/>
              <a:t>  Mouse cell-depleted </a:t>
            </a:r>
            <a:r>
              <a:rPr lang="en-MY" sz="1400" b="1" dirty="0"/>
              <a:t>(2D)         </a:t>
            </a:r>
            <a:r>
              <a:rPr lang="en-MY" sz="1400" b="1" dirty="0" smtClean="0"/>
              <a:t>  </a:t>
            </a:r>
            <a:r>
              <a:rPr lang="en-MY" sz="1400" b="1" dirty="0"/>
              <a:t>Spheroids (3D)  </a:t>
            </a:r>
          </a:p>
        </p:txBody>
      </p:sp>
      <p:cxnSp>
        <p:nvCxnSpPr>
          <p:cNvPr id="45" name="Straight Connector 44"/>
          <p:cNvCxnSpPr/>
          <p:nvPr/>
        </p:nvCxnSpPr>
        <p:spPr>
          <a:xfrm>
            <a:off x="4994108" y="4246476"/>
            <a:ext cx="0" cy="142875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9" name="Chart 28"/>
          <p:cNvGraphicFramePr/>
          <p:nvPr/>
        </p:nvGraphicFramePr>
        <p:xfrm>
          <a:off x="2129589" y="254000"/>
          <a:ext cx="2785312" cy="194012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30" name="Chart 29"/>
          <p:cNvGraphicFramePr/>
          <p:nvPr/>
        </p:nvGraphicFramePr>
        <p:xfrm>
          <a:off x="2120152" y="2194124"/>
          <a:ext cx="2794748" cy="198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42" name="TextBox 41"/>
          <p:cNvSpPr txBox="1"/>
          <p:nvPr/>
        </p:nvSpPr>
        <p:spPr>
          <a:xfrm>
            <a:off x="3439314" y="1530152"/>
            <a:ext cx="9513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R</a:t>
            </a:r>
            <a:r>
              <a:rPr lang="en-US" sz="1000" baseline="30000" dirty="0"/>
              <a:t>2</a:t>
            </a:r>
            <a:r>
              <a:rPr lang="en-US" sz="1000" dirty="0"/>
              <a:t> = 0.9984</a:t>
            </a:r>
            <a:endParaRPr lang="en-MY" sz="1000" baseline="30000" dirty="0"/>
          </a:p>
        </p:txBody>
      </p:sp>
      <p:sp>
        <p:nvSpPr>
          <p:cNvPr id="52" name="TextBox 51"/>
          <p:cNvSpPr txBox="1"/>
          <p:nvPr/>
        </p:nvSpPr>
        <p:spPr>
          <a:xfrm>
            <a:off x="2700049" y="1130816"/>
            <a:ext cx="9513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R</a:t>
            </a:r>
            <a:r>
              <a:rPr lang="en-US" sz="1000" baseline="30000" dirty="0"/>
              <a:t>2</a:t>
            </a:r>
            <a:r>
              <a:rPr lang="en-US" sz="1000" dirty="0"/>
              <a:t> = 0.9958</a:t>
            </a:r>
            <a:endParaRPr lang="en-MY" sz="1000" baseline="30000" dirty="0"/>
          </a:p>
        </p:txBody>
      </p:sp>
      <p:sp>
        <p:nvSpPr>
          <p:cNvPr id="54" name="TextBox 53"/>
          <p:cNvSpPr txBox="1"/>
          <p:nvPr/>
        </p:nvSpPr>
        <p:spPr>
          <a:xfrm>
            <a:off x="2725711" y="3113327"/>
            <a:ext cx="9513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R</a:t>
            </a:r>
            <a:r>
              <a:rPr lang="en-US" sz="1000" baseline="30000" dirty="0"/>
              <a:t>2</a:t>
            </a:r>
            <a:r>
              <a:rPr lang="en-US" sz="1000" dirty="0"/>
              <a:t> = 0.9974</a:t>
            </a:r>
            <a:endParaRPr lang="en-MY" sz="1000" baseline="30000" dirty="0"/>
          </a:p>
        </p:txBody>
      </p:sp>
      <p:sp>
        <p:nvSpPr>
          <p:cNvPr id="55" name="TextBox 54"/>
          <p:cNvSpPr txBox="1"/>
          <p:nvPr/>
        </p:nvSpPr>
        <p:spPr>
          <a:xfrm>
            <a:off x="3480506" y="3560770"/>
            <a:ext cx="9513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R</a:t>
            </a:r>
            <a:r>
              <a:rPr lang="en-US" sz="1000" baseline="30000" dirty="0"/>
              <a:t>2</a:t>
            </a:r>
            <a:r>
              <a:rPr lang="en-US" sz="1000" dirty="0"/>
              <a:t> = 0.983</a:t>
            </a:r>
            <a:endParaRPr lang="en-MY" sz="1000" baseline="30000" dirty="0"/>
          </a:p>
        </p:txBody>
      </p:sp>
      <p:sp>
        <p:nvSpPr>
          <p:cNvPr id="57" name="TextBox 56"/>
          <p:cNvSpPr txBox="1"/>
          <p:nvPr/>
        </p:nvSpPr>
        <p:spPr>
          <a:xfrm>
            <a:off x="2774619" y="5128517"/>
            <a:ext cx="9513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R</a:t>
            </a:r>
            <a:r>
              <a:rPr lang="en-US" sz="1000" baseline="30000" dirty="0"/>
              <a:t>2</a:t>
            </a:r>
            <a:r>
              <a:rPr lang="en-US" sz="1000" dirty="0"/>
              <a:t> = 0.9843</a:t>
            </a:r>
            <a:endParaRPr lang="en-MY" sz="1000" baseline="30000" dirty="0"/>
          </a:p>
        </p:txBody>
      </p:sp>
      <p:sp>
        <p:nvSpPr>
          <p:cNvPr id="59" name="TextBox 58"/>
          <p:cNvSpPr txBox="1"/>
          <p:nvPr/>
        </p:nvSpPr>
        <p:spPr>
          <a:xfrm>
            <a:off x="3490726" y="5461727"/>
            <a:ext cx="9513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R</a:t>
            </a:r>
            <a:r>
              <a:rPr lang="en-US" sz="1000" baseline="30000" dirty="0"/>
              <a:t>2</a:t>
            </a:r>
            <a:r>
              <a:rPr lang="en-US" sz="1000" dirty="0"/>
              <a:t> = 0.9923  </a:t>
            </a:r>
            <a:endParaRPr lang="en-MY" sz="1000" baseline="300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0</TotalTime>
  <Words>52</Words>
  <Application>Microsoft Office PowerPoint</Application>
  <PresentationFormat>On-screen Show (4:3)</PresentationFormat>
  <Paragraphs>1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user</dc:creator>
  <cp:lastModifiedBy>Dr. Ronald Teow Sin Yeang</cp:lastModifiedBy>
  <cp:revision>643</cp:revision>
  <dcterms:created xsi:type="dcterms:W3CDTF">2006-08-16T00:00:00Z</dcterms:created>
  <dcterms:modified xsi:type="dcterms:W3CDTF">2019-04-15T09:44:5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10.2.0.7439</vt:lpwstr>
  </property>
</Properties>
</file>